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4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68" d="100"/>
          <a:sy n="68" d="100"/>
        </p:scale>
        <p:origin x="73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D794F4-E24B-4C3A-8DE7-8644BA2523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8C3AD24-262E-48BC-A448-191201D62E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BA800E-ADA8-477B-BBFC-0A7F899F0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E49F798-FD2B-4130-ACB2-CCA3DC4B62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C38B6BB-288D-4171-BBDA-DBC99E46E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8331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29BC7A-9904-4420-A177-0B4824DBF6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F283BAE-8F74-410B-9C96-6E81A5ADDF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9A8226A-468B-4546-BA59-89A6AE4B9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31E441E-A9B1-4774-BC4F-BBA3F67BA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CB4BFE2-0F35-40C6-B2C3-D3D9A0705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6270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5869236-FDC7-4D96-8AED-B5D7E7581F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3B1EF50-7D2A-4748-B2F2-FC4D98C170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E807BD-4786-4C20-8062-8D30011E4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E7DCFD0-A0D1-4347-BA44-13D984572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CFA070-029E-4735-BE88-D500ECF1C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7512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CB7339-993D-4FA5-983D-A25565452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B47DAD3-E5E8-4B77-90EE-85559A52A9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B53BDF-81F5-4F8F-AFDF-5A6B4AA9F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29D9C04-42B6-4127-9843-4FA0C6F18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7C614B-1C4C-4D6D-A0D8-F1F0E9002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9189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0A6805-5391-4E95-9FE0-B47BF988E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9AFC12C-9152-4F98-A17C-9BB4D51F80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70902CD-EFDF-4875-A521-8B4E3D081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5727A39-7441-4A35-9BE0-EA2CC1AFE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AC4AE2E-7F80-4136-9A9D-8495C05E6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0263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3131A7-59FC-4143-AFB9-61D62FBD43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1187DF-B6CE-419F-8591-FEA7CB0077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F17C53F-EEBA-44A4-93C4-45FE81163A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7F3DFA8-CF3D-439D-A4ED-78C2E8B4A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EE11231-4D9E-4E7E-BCD9-29E577E60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78DBCEE-06D6-45E6-A437-9A13B38B5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1937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1A5D13-433A-4C32-9377-E9E9CB814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96B9F03-B5D8-4411-AF29-0D6DBB765C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034E265-D882-4DF4-9616-C77492F73F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956D15D-844B-41D2-9C3C-C28AA875E6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E304CC8-348C-4DCE-9D90-43DADF4939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86BCF52-C358-43AA-9AF6-40F6D0FA0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70C02941-E7D3-4F3A-818E-FBF43D25A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6C21B59-AC8C-4F42-BA4D-4BBDEDCC5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8302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2FCBAB-BD40-4C04-B815-B861D74745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F55B1DB-BEA0-4D8A-8F3D-EFFDFA5EC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3D4AA13-C723-47DD-AE5D-73E7DA4F33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2C6CC98-7162-4B63-9D10-73387AAD3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505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E06B809-293D-4A41-980C-41F6E8EC74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2783A2A-84E3-4E5D-BC51-18D66AE27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3C0139A-BD26-4D58-BA2D-4C4FFB2E1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991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2F73F1-1F5E-47BE-9822-7E8D75CBF3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CAA0D1B-CF27-4B03-819E-D30A047BDB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27CEC52-2772-4F6A-9ACB-435629502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39EC593-D518-4752-8BF9-36A51FC5E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1BF9124-C299-487E-87F0-5104F3027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9D7E7BC-F925-4847-8636-7370A4F22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729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7A4B86D-21AE-459A-B75D-444345B57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4E9E3C4-9994-458F-B88B-3D1EB2F14B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D3254EA-5F8A-467F-ADC6-16F1533EEE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25A3CAB-D840-486C-9249-BEE944D01A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007D05F-2401-4BE9-A2C9-29E32A6952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8EC34F3-15C8-479A-90C6-70CE0D6469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532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B40E1D7-86FC-4335-BC71-47C3751E9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FB86F34-1E8F-4059-B9E8-231681B13B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3D2838-EAC2-4351-93C6-833B389258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7FC53-56C1-47EF-9D2C-EDEC9D01CE80}" type="datetimeFigureOut">
              <a:rPr lang="ko-KR" altLang="en-US" smtClean="0"/>
              <a:t>2023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096AB80-D735-4F56-B486-DFADE9AD98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0C81C39-724B-4D61-BD6A-9A3850C71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2123E-D11D-4614-9452-8AE2F418B7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6172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F8A73641-8C12-4F5F-BFC4-8B2D1B8A94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0508" y="1331589"/>
            <a:ext cx="1304925" cy="986878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8116B8EE-C268-407F-A006-07A5A9C514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30506" y="2438406"/>
            <a:ext cx="1304925" cy="990600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33046276-6048-4BA3-821D-D1436BE69A5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30508" y="3520092"/>
            <a:ext cx="1304925" cy="988288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D999A301-584A-4F19-82C6-9C4832C542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30508" y="4599466"/>
            <a:ext cx="1304925" cy="966787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EEC54E42-760E-4D05-9379-1F3B4966C06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49039" y="5660126"/>
            <a:ext cx="1304925" cy="103892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25D74D0-5DE2-40BE-997C-DE084DC96C9F}"/>
              </a:ext>
            </a:extLst>
          </p:cNvPr>
          <p:cNvSpPr txBox="1"/>
          <p:nvPr/>
        </p:nvSpPr>
        <p:spPr>
          <a:xfrm>
            <a:off x="3055785" y="897513"/>
            <a:ext cx="7873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apsaicin</a:t>
            </a:r>
          </a:p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(5 m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397FFD1-0AEF-4081-84B1-F6E1196CC4C8}"/>
              </a:ext>
            </a:extLst>
          </p:cNvPr>
          <p:cNvSpPr txBox="1"/>
          <p:nvPr/>
        </p:nvSpPr>
        <p:spPr>
          <a:xfrm>
            <a:off x="3824533" y="897513"/>
            <a:ext cx="7649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apsaicin</a:t>
            </a:r>
          </a:p>
        </p:txBody>
      </p:sp>
      <p:sp>
        <p:nvSpPr>
          <p:cNvPr id="19" name="타원 18">
            <a:extLst>
              <a:ext uri="{FF2B5EF4-FFF2-40B4-BE49-F238E27FC236}">
                <a16:creationId xmlns:a16="http://schemas.microsoft.com/office/drawing/2014/main" id="{AC2F54B6-4F76-4232-8915-8A3A902CF357}"/>
              </a:ext>
            </a:extLst>
          </p:cNvPr>
          <p:cNvSpPr/>
          <p:nvPr/>
        </p:nvSpPr>
        <p:spPr>
          <a:xfrm>
            <a:off x="3130507" y="1457596"/>
            <a:ext cx="392869" cy="161792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타원 19">
            <a:extLst>
              <a:ext uri="{FF2B5EF4-FFF2-40B4-BE49-F238E27FC236}">
                <a16:creationId xmlns:a16="http://schemas.microsoft.com/office/drawing/2014/main" id="{B6E55BB9-54D9-441E-B27C-527991189B76}"/>
              </a:ext>
            </a:extLst>
          </p:cNvPr>
          <p:cNvSpPr/>
          <p:nvPr/>
        </p:nvSpPr>
        <p:spPr>
          <a:xfrm flipV="1">
            <a:off x="4041043" y="1378163"/>
            <a:ext cx="392869" cy="161791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타원 20">
            <a:extLst>
              <a:ext uri="{FF2B5EF4-FFF2-40B4-BE49-F238E27FC236}">
                <a16:creationId xmlns:a16="http://schemas.microsoft.com/office/drawing/2014/main" id="{AF429180-4CE2-4AA1-A247-B16281BAC9A4}"/>
              </a:ext>
            </a:extLst>
          </p:cNvPr>
          <p:cNvSpPr/>
          <p:nvPr/>
        </p:nvSpPr>
        <p:spPr>
          <a:xfrm>
            <a:off x="3956697" y="2893221"/>
            <a:ext cx="363633" cy="244264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타원 22">
            <a:extLst>
              <a:ext uri="{FF2B5EF4-FFF2-40B4-BE49-F238E27FC236}">
                <a16:creationId xmlns:a16="http://schemas.microsoft.com/office/drawing/2014/main" id="{1A5B2119-1CDB-416C-9213-A7E3209FE146}"/>
              </a:ext>
            </a:extLst>
          </p:cNvPr>
          <p:cNvSpPr/>
          <p:nvPr/>
        </p:nvSpPr>
        <p:spPr>
          <a:xfrm>
            <a:off x="3130505" y="2560707"/>
            <a:ext cx="556781" cy="161792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타원 23">
            <a:extLst>
              <a:ext uri="{FF2B5EF4-FFF2-40B4-BE49-F238E27FC236}">
                <a16:creationId xmlns:a16="http://schemas.microsoft.com/office/drawing/2014/main" id="{05A83A2B-1A65-4791-8D84-A616484D2CFC}"/>
              </a:ext>
            </a:extLst>
          </p:cNvPr>
          <p:cNvSpPr/>
          <p:nvPr/>
        </p:nvSpPr>
        <p:spPr>
          <a:xfrm>
            <a:off x="3130505" y="3636483"/>
            <a:ext cx="556781" cy="214026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타원 26">
            <a:extLst>
              <a:ext uri="{FF2B5EF4-FFF2-40B4-BE49-F238E27FC236}">
                <a16:creationId xmlns:a16="http://schemas.microsoft.com/office/drawing/2014/main" id="{79076338-0BC0-4310-8246-B1A68F06E92B}"/>
              </a:ext>
            </a:extLst>
          </p:cNvPr>
          <p:cNvSpPr/>
          <p:nvPr/>
        </p:nvSpPr>
        <p:spPr>
          <a:xfrm>
            <a:off x="3897973" y="3959054"/>
            <a:ext cx="424617" cy="278484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타원 27">
            <a:extLst>
              <a:ext uri="{FF2B5EF4-FFF2-40B4-BE49-F238E27FC236}">
                <a16:creationId xmlns:a16="http://schemas.microsoft.com/office/drawing/2014/main" id="{C7C00641-1C97-4814-A4D9-8B9D385EFC75}"/>
              </a:ext>
            </a:extLst>
          </p:cNvPr>
          <p:cNvSpPr/>
          <p:nvPr/>
        </p:nvSpPr>
        <p:spPr>
          <a:xfrm>
            <a:off x="3956697" y="5003194"/>
            <a:ext cx="363633" cy="326518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타원 28">
            <a:extLst>
              <a:ext uri="{FF2B5EF4-FFF2-40B4-BE49-F238E27FC236}">
                <a16:creationId xmlns:a16="http://schemas.microsoft.com/office/drawing/2014/main" id="{811E5AAC-A74B-47F5-AD8E-6DDB21650898}"/>
              </a:ext>
            </a:extLst>
          </p:cNvPr>
          <p:cNvSpPr/>
          <p:nvPr/>
        </p:nvSpPr>
        <p:spPr>
          <a:xfrm>
            <a:off x="3840596" y="5980416"/>
            <a:ext cx="383214" cy="278484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F2688F6-B29D-4BAA-9FEF-B5E05E149086}"/>
              </a:ext>
            </a:extLst>
          </p:cNvPr>
          <p:cNvSpPr txBox="1"/>
          <p:nvPr/>
        </p:nvSpPr>
        <p:spPr>
          <a:xfrm>
            <a:off x="2541850" y="1619388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0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1099524-7F0A-44B2-AC70-DC1A96221830}"/>
              </a:ext>
            </a:extLst>
          </p:cNvPr>
          <p:cNvSpPr txBox="1"/>
          <p:nvPr/>
        </p:nvSpPr>
        <p:spPr>
          <a:xfrm>
            <a:off x="2541850" y="2814556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2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064BB5F-2048-4C65-A9D1-6B295F8DC3B5}"/>
              </a:ext>
            </a:extLst>
          </p:cNvPr>
          <p:cNvSpPr txBox="1"/>
          <p:nvPr/>
        </p:nvSpPr>
        <p:spPr>
          <a:xfrm>
            <a:off x="2541850" y="3882703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4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D75A8AC-A428-4490-AB84-E45E2E881DC9}"/>
              </a:ext>
            </a:extLst>
          </p:cNvPr>
          <p:cNvSpPr txBox="1"/>
          <p:nvPr/>
        </p:nvSpPr>
        <p:spPr>
          <a:xfrm>
            <a:off x="2541850" y="5003194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6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DF6B5FC-79A6-49B5-BEB4-8568144CA6E8}"/>
              </a:ext>
            </a:extLst>
          </p:cNvPr>
          <p:cNvSpPr txBox="1"/>
          <p:nvPr/>
        </p:nvSpPr>
        <p:spPr>
          <a:xfrm>
            <a:off x="2541850" y="6148110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8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 Box 20">
            <a:extLst>
              <a:ext uri="{FF2B5EF4-FFF2-40B4-BE49-F238E27FC236}">
                <a16:creationId xmlns:a16="http://schemas.microsoft.com/office/drawing/2014/main" id="{6D921908-7D4C-430E-935B-9BFA8E8FC1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34425" y="29688"/>
            <a:ext cx="55335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Fig S4</a:t>
            </a:r>
          </a:p>
        </p:txBody>
      </p:sp>
      <p:pic>
        <p:nvPicPr>
          <p:cNvPr id="37" name="그림 36">
            <a:extLst>
              <a:ext uri="{FF2B5EF4-FFF2-40B4-BE49-F238E27FC236}">
                <a16:creationId xmlns:a16="http://schemas.microsoft.com/office/drawing/2014/main" id="{FEDB6161-A7DE-487E-956E-37D91073D43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27" r="24995"/>
          <a:stretch/>
        </p:blipFill>
        <p:spPr>
          <a:xfrm flipH="1">
            <a:off x="5599143" y="1331589"/>
            <a:ext cx="1286929" cy="909080"/>
          </a:xfrm>
          <a:prstGeom prst="rect">
            <a:avLst/>
          </a:prstGeom>
        </p:spPr>
      </p:pic>
      <p:pic>
        <p:nvPicPr>
          <p:cNvPr id="38" name="그림 37">
            <a:extLst>
              <a:ext uri="{FF2B5EF4-FFF2-40B4-BE49-F238E27FC236}">
                <a16:creationId xmlns:a16="http://schemas.microsoft.com/office/drawing/2014/main" id="{BA9850BA-EDED-4C54-8903-BB5696777725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07" r="24995"/>
          <a:stretch/>
        </p:blipFill>
        <p:spPr>
          <a:xfrm flipH="1">
            <a:off x="5599141" y="2455610"/>
            <a:ext cx="1286927" cy="906019"/>
          </a:xfrm>
          <a:prstGeom prst="rect">
            <a:avLst/>
          </a:prstGeom>
        </p:spPr>
      </p:pic>
      <p:pic>
        <p:nvPicPr>
          <p:cNvPr id="39" name="그림 38">
            <a:extLst>
              <a:ext uri="{FF2B5EF4-FFF2-40B4-BE49-F238E27FC236}">
                <a16:creationId xmlns:a16="http://schemas.microsoft.com/office/drawing/2014/main" id="{EE57E405-89B2-4AF6-96AD-D006DF77B29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31" r="19771"/>
          <a:stretch/>
        </p:blipFill>
        <p:spPr>
          <a:xfrm flipH="1">
            <a:off x="5581143" y="3554302"/>
            <a:ext cx="1304925" cy="918689"/>
          </a:xfrm>
          <a:prstGeom prst="rect">
            <a:avLst/>
          </a:prstGeom>
        </p:spPr>
      </p:pic>
      <p:pic>
        <p:nvPicPr>
          <p:cNvPr id="40" name="그림 39">
            <a:extLst>
              <a:ext uri="{FF2B5EF4-FFF2-40B4-BE49-F238E27FC236}">
                <a16:creationId xmlns:a16="http://schemas.microsoft.com/office/drawing/2014/main" id="{81CEBDB4-9B24-4788-AF9D-091A5680BF6C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22" r="21317"/>
          <a:stretch/>
        </p:blipFill>
        <p:spPr>
          <a:xfrm flipH="1">
            <a:off x="5599141" y="4689448"/>
            <a:ext cx="1304925" cy="909502"/>
          </a:xfrm>
          <a:prstGeom prst="rect">
            <a:avLst/>
          </a:prstGeom>
        </p:spPr>
      </p:pic>
      <p:pic>
        <p:nvPicPr>
          <p:cNvPr id="41" name="그림 40">
            <a:extLst>
              <a:ext uri="{FF2B5EF4-FFF2-40B4-BE49-F238E27FC236}">
                <a16:creationId xmlns:a16="http://schemas.microsoft.com/office/drawing/2014/main" id="{3F708DA0-16E1-4DDF-9046-714BB5134BA3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3" r="19992"/>
          <a:stretch/>
        </p:blipFill>
        <p:spPr>
          <a:xfrm flipH="1">
            <a:off x="5599141" y="5813891"/>
            <a:ext cx="1286927" cy="885156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C05EC625-E128-44D1-B507-442A35574914}"/>
              </a:ext>
            </a:extLst>
          </p:cNvPr>
          <p:cNvSpPr txBox="1"/>
          <p:nvPr/>
        </p:nvSpPr>
        <p:spPr>
          <a:xfrm>
            <a:off x="5565612" y="870755"/>
            <a:ext cx="7873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apsaicin</a:t>
            </a:r>
          </a:p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(5 mM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743D80F-3F5D-4751-B6B6-04FF2C5AE3F9}"/>
              </a:ext>
            </a:extLst>
          </p:cNvPr>
          <p:cNvSpPr txBox="1"/>
          <p:nvPr/>
        </p:nvSpPr>
        <p:spPr>
          <a:xfrm>
            <a:off x="6257168" y="870755"/>
            <a:ext cx="76495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</a:p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apsaicin</a:t>
            </a:r>
          </a:p>
          <a:p>
            <a:pPr algn="ctr"/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75D41D5-3ACF-420D-8E83-4CDC33653D95}"/>
              </a:ext>
            </a:extLst>
          </p:cNvPr>
          <p:cNvSpPr txBox="1"/>
          <p:nvPr/>
        </p:nvSpPr>
        <p:spPr>
          <a:xfrm>
            <a:off x="4982118" y="1603148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20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7248C7E-DB89-437E-869A-F531087BA5F2}"/>
              </a:ext>
            </a:extLst>
          </p:cNvPr>
          <p:cNvSpPr txBox="1"/>
          <p:nvPr/>
        </p:nvSpPr>
        <p:spPr>
          <a:xfrm>
            <a:off x="4982118" y="3882703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40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2B9BC7A-D267-4BD2-A216-8EA53DDFF39F}"/>
              </a:ext>
            </a:extLst>
          </p:cNvPr>
          <p:cNvSpPr txBox="1"/>
          <p:nvPr/>
        </p:nvSpPr>
        <p:spPr>
          <a:xfrm>
            <a:off x="4982118" y="2798316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30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2981AFA-6030-4986-BA22-F178F63C0B4B}"/>
              </a:ext>
            </a:extLst>
          </p:cNvPr>
          <p:cNvSpPr txBox="1"/>
          <p:nvPr/>
        </p:nvSpPr>
        <p:spPr>
          <a:xfrm>
            <a:off x="4982118" y="5003194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50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36DAC75-D651-4AD2-88B2-8A6FC06BEA5A}"/>
              </a:ext>
            </a:extLst>
          </p:cNvPr>
          <p:cNvSpPr txBox="1"/>
          <p:nvPr/>
        </p:nvSpPr>
        <p:spPr>
          <a:xfrm>
            <a:off x="4982118" y="6148110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60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타원 48">
            <a:extLst>
              <a:ext uri="{FF2B5EF4-FFF2-40B4-BE49-F238E27FC236}">
                <a16:creationId xmlns:a16="http://schemas.microsoft.com/office/drawing/2014/main" id="{22EF6BB9-8A9F-447E-A088-EE77E6753B46}"/>
              </a:ext>
            </a:extLst>
          </p:cNvPr>
          <p:cNvSpPr/>
          <p:nvPr/>
        </p:nvSpPr>
        <p:spPr>
          <a:xfrm>
            <a:off x="3149038" y="4689447"/>
            <a:ext cx="460201" cy="278484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0" name="타원 49">
            <a:extLst>
              <a:ext uri="{FF2B5EF4-FFF2-40B4-BE49-F238E27FC236}">
                <a16:creationId xmlns:a16="http://schemas.microsoft.com/office/drawing/2014/main" id="{18076A4A-135E-4E66-AC34-CA73D003D6CA}"/>
              </a:ext>
            </a:extLst>
          </p:cNvPr>
          <p:cNvSpPr/>
          <p:nvPr/>
        </p:nvSpPr>
        <p:spPr>
          <a:xfrm>
            <a:off x="3149039" y="5830979"/>
            <a:ext cx="315614" cy="233179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1" name="타원 50">
            <a:extLst>
              <a:ext uri="{FF2B5EF4-FFF2-40B4-BE49-F238E27FC236}">
                <a16:creationId xmlns:a16="http://schemas.microsoft.com/office/drawing/2014/main" id="{BEBDFB25-C74B-405A-97DF-0F87FDA20D5B}"/>
              </a:ext>
            </a:extLst>
          </p:cNvPr>
          <p:cNvSpPr/>
          <p:nvPr/>
        </p:nvSpPr>
        <p:spPr>
          <a:xfrm>
            <a:off x="5644977" y="1312080"/>
            <a:ext cx="496960" cy="287785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3" name="타원 52">
            <a:extLst>
              <a:ext uri="{FF2B5EF4-FFF2-40B4-BE49-F238E27FC236}">
                <a16:creationId xmlns:a16="http://schemas.microsoft.com/office/drawing/2014/main" id="{BA141332-3930-411D-973E-5B922AA2674B}"/>
              </a:ext>
            </a:extLst>
          </p:cNvPr>
          <p:cNvSpPr/>
          <p:nvPr/>
        </p:nvSpPr>
        <p:spPr>
          <a:xfrm>
            <a:off x="5644977" y="2430846"/>
            <a:ext cx="496960" cy="287785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4" name="타원 53">
            <a:extLst>
              <a:ext uri="{FF2B5EF4-FFF2-40B4-BE49-F238E27FC236}">
                <a16:creationId xmlns:a16="http://schemas.microsoft.com/office/drawing/2014/main" id="{754640AF-4731-45CF-9659-AE7C14A389A1}"/>
              </a:ext>
            </a:extLst>
          </p:cNvPr>
          <p:cNvSpPr/>
          <p:nvPr/>
        </p:nvSpPr>
        <p:spPr>
          <a:xfrm>
            <a:off x="5599141" y="3576570"/>
            <a:ext cx="496960" cy="287785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5" name="타원 54">
            <a:extLst>
              <a:ext uri="{FF2B5EF4-FFF2-40B4-BE49-F238E27FC236}">
                <a16:creationId xmlns:a16="http://schemas.microsoft.com/office/drawing/2014/main" id="{C652F7F4-1BE3-4EC0-9836-D88517FBED73}"/>
              </a:ext>
            </a:extLst>
          </p:cNvPr>
          <p:cNvSpPr/>
          <p:nvPr/>
        </p:nvSpPr>
        <p:spPr>
          <a:xfrm>
            <a:off x="5636588" y="4647752"/>
            <a:ext cx="496960" cy="287785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6" name="타원 55">
            <a:extLst>
              <a:ext uri="{FF2B5EF4-FFF2-40B4-BE49-F238E27FC236}">
                <a16:creationId xmlns:a16="http://schemas.microsoft.com/office/drawing/2014/main" id="{DCD0FD78-4FF4-4CF4-8638-16F1F3E00216}"/>
              </a:ext>
            </a:extLst>
          </p:cNvPr>
          <p:cNvSpPr/>
          <p:nvPr/>
        </p:nvSpPr>
        <p:spPr>
          <a:xfrm>
            <a:off x="5644977" y="5830979"/>
            <a:ext cx="496960" cy="287785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7" name="타원 56">
            <a:extLst>
              <a:ext uri="{FF2B5EF4-FFF2-40B4-BE49-F238E27FC236}">
                <a16:creationId xmlns:a16="http://schemas.microsoft.com/office/drawing/2014/main" id="{36E57782-6758-4F29-9AD1-67E9DFE59B7B}"/>
              </a:ext>
            </a:extLst>
          </p:cNvPr>
          <p:cNvSpPr/>
          <p:nvPr/>
        </p:nvSpPr>
        <p:spPr>
          <a:xfrm>
            <a:off x="6311329" y="1940914"/>
            <a:ext cx="484949" cy="212480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8" name="타원 57">
            <a:extLst>
              <a:ext uri="{FF2B5EF4-FFF2-40B4-BE49-F238E27FC236}">
                <a16:creationId xmlns:a16="http://schemas.microsoft.com/office/drawing/2014/main" id="{8BCC4B87-BBAF-48A8-9412-C8FC061CF8C1}"/>
              </a:ext>
            </a:extLst>
          </p:cNvPr>
          <p:cNvSpPr/>
          <p:nvPr/>
        </p:nvSpPr>
        <p:spPr>
          <a:xfrm>
            <a:off x="6279076" y="3054685"/>
            <a:ext cx="470660" cy="173147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9" name="타원 58">
            <a:extLst>
              <a:ext uri="{FF2B5EF4-FFF2-40B4-BE49-F238E27FC236}">
                <a16:creationId xmlns:a16="http://schemas.microsoft.com/office/drawing/2014/main" id="{599D16AF-02FE-4445-BA4C-03E6FAD550CF}"/>
              </a:ext>
            </a:extLst>
          </p:cNvPr>
          <p:cNvSpPr/>
          <p:nvPr/>
        </p:nvSpPr>
        <p:spPr>
          <a:xfrm>
            <a:off x="6286162" y="4132327"/>
            <a:ext cx="470660" cy="173147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0" name="타원 59">
            <a:extLst>
              <a:ext uri="{FF2B5EF4-FFF2-40B4-BE49-F238E27FC236}">
                <a16:creationId xmlns:a16="http://schemas.microsoft.com/office/drawing/2014/main" id="{725E1369-C646-4393-86FD-0506AB3819A2}"/>
              </a:ext>
            </a:extLst>
          </p:cNvPr>
          <p:cNvSpPr/>
          <p:nvPr/>
        </p:nvSpPr>
        <p:spPr>
          <a:xfrm>
            <a:off x="6334360" y="5243138"/>
            <a:ext cx="470660" cy="173147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1" name="타원 60">
            <a:extLst>
              <a:ext uri="{FF2B5EF4-FFF2-40B4-BE49-F238E27FC236}">
                <a16:creationId xmlns:a16="http://schemas.microsoft.com/office/drawing/2014/main" id="{3F664C42-1F28-4574-B4A9-AC5C0AEB4523}"/>
              </a:ext>
            </a:extLst>
          </p:cNvPr>
          <p:cNvSpPr/>
          <p:nvPr/>
        </p:nvSpPr>
        <p:spPr>
          <a:xfrm>
            <a:off x="6345367" y="6384001"/>
            <a:ext cx="470660" cy="173147"/>
          </a:xfrm>
          <a:prstGeom prst="ellipse">
            <a:avLst/>
          </a:prstGeom>
          <a:noFill/>
          <a:ln w="1270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2" name="Text Box 6">
            <a:extLst>
              <a:ext uri="{FF2B5EF4-FFF2-40B4-BE49-F238E27FC236}">
                <a16:creationId xmlns:a16="http://schemas.microsoft.com/office/drawing/2014/main" id="{2589B454-8122-4874-A380-E66899FBE8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78399" y="329389"/>
            <a:ext cx="131478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md-TRPV1(3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) flies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752EE14-F6A3-449E-97D0-E5A93CE6EE28}"/>
              </a:ext>
            </a:extLst>
          </p:cNvPr>
          <p:cNvSpPr txBox="1"/>
          <p:nvPr/>
        </p:nvSpPr>
        <p:spPr>
          <a:xfrm>
            <a:off x="3835053" y="70584"/>
            <a:ext cx="23342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ipping behavior over</a:t>
            </a:r>
            <a:r>
              <a: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60 mi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429D1622-C56E-4577-B1FA-4619EBC1972D}"/>
              </a:ext>
            </a:extLst>
          </p:cNvPr>
          <p:cNvCxnSpPr/>
          <p:nvPr/>
        </p:nvCxnSpPr>
        <p:spPr>
          <a:xfrm>
            <a:off x="3206338" y="700646"/>
            <a:ext cx="374072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72821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7</TotalTime>
  <Words>45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aranya Siva</cp:lastModifiedBy>
  <cp:revision>149</cp:revision>
  <dcterms:created xsi:type="dcterms:W3CDTF">2022-10-18T02:31:52Z</dcterms:created>
  <dcterms:modified xsi:type="dcterms:W3CDTF">2023-02-08T08:35:13Z</dcterms:modified>
</cp:coreProperties>
</file>